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A99A86-CE02-4109-890F-1E4692B415B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EA71AC-7765-4037-B05C-FBD0F44B144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22BF74-E67D-472E-8D1F-D11265DAA2A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1F809A-C14A-40D3-AFB6-C93A2CC0965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F2E3B3-7D7B-4E2B-BFBD-5F0B87B2AD3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B227BB-722B-4791-BF13-A095FAD1241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C3E42A-9163-4C6E-81FB-4B0F1F6ED80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2147AF-8806-47A4-A388-2E44EC8FA5A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B52E33-7552-405A-BE10-E59DE4A93F2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9ED6AE-0C5C-4C38-8538-7FE37B3B91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1F6FA8-F7AF-49C4-AE24-A40AFBF7C8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B8EFEC-836A-4538-81DB-73C73657FCC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898989"/>
                </a:solidFill>
                <a:latin typeface="맑은 고딕"/>
              </a:rPr>
              <a:t>&lt;date/time&gt;</a:t>
            </a:r>
            <a:endParaRPr b="1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AC01B24-9482-4FE6-935B-905F20EEDE83}" type="slidenum">
              <a:rPr b="0" lang="ko-KR" sz="1200" spc="-1" strike="noStrike">
                <a:solidFill>
                  <a:srgbClr val="898989"/>
                </a:solidFill>
                <a:latin typeface="맑은 고딕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image" Target="../media/image5.png"/><Relationship Id="rId4" Type="http://schemas.openxmlformats.org/officeDocument/2006/relationships/image" Target="../media/image6.png"/><Relationship Id="rId5" Type="http://schemas.openxmlformats.org/officeDocument/2006/relationships/image" Target="../media/image7.png"/><Relationship Id="rId6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image" Target="../media/image9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직사각형 1"/>
          <p:cNvSpPr/>
          <p:nvPr/>
        </p:nvSpPr>
        <p:spPr>
          <a:xfrm>
            <a:off x="162000" y="285840"/>
            <a:ext cx="399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(1) SHIP-1 antibody confirming test</a:t>
            </a:r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42" name="Picture 3" descr=""/>
          <p:cNvPicPr/>
          <p:nvPr/>
        </p:nvPicPr>
        <p:blipFill>
          <a:blip r:embed="rId1"/>
          <a:stretch/>
        </p:blipFill>
        <p:spPr>
          <a:xfrm>
            <a:off x="1598760" y="857160"/>
            <a:ext cx="3112920" cy="1994040"/>
          </a:xfrm>
          <a:prstGeom prst="rect">
            <a:avLst/>
          </a:prstGeom>
          <a:ln w="0">
            <a:noFill/>
          </a:ln>
        </p:spPr>
      </p:pic>
      <p:sp>
        <p:nvSpPr>
          <p:cNvPr id="43" name="직선 연결선 3"/>
          <p:cNvSpPr/>
          <p:nvPr/>
        </p:nvSpPr>
        <p:spPr>
          <a:xfrm>
            <a:off x="1741320" y="1428840"/>
            <a:ext cx="428760" cy="1440"/>
          </a:xfrm>
          <a:prstGeom prst="line">
            <a:avLst/>
          </a:prstGeom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4" name="직선 연결선 4"/>
          <p:cNvSpPr/>
          <p:nvPr/>
        </p:nvSpPr>
        <p:spPr>
          <a:xfrm>
            <a:off x="1747800" y="1792440"/>
            <a:ext cx="428760" cy="1440"/>
          </a:xfrm>
          <a:prstGeom prst="line">
            <a:avLst/>
          </a:prstGeom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5" name="TextBox 5"/>
          <p:cNvSpPr/>
          <p:nvPr/>
        </p:nvSpPr>
        <p:spPr>
          <a:xfrm>
            <a:off x="1738080" y="92880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Lane 1</a:t>
            </a:r>
            <a:endParaRPr b="1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6" name="TextBox 6"/>
          <p:cNvSpPr/>
          <p:nvPr/>
        </p:nvSpPr>
        <p:spPr>
          <a:xfrm>
            <a:off x="2358720" y="92880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Lane 2</a:t>
            </a:r>
            <a:endParaRPr b="1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7" name="TextBox 7"/>
          <p:cNvSpPr/>
          <p:nvPr/>
        </p:nvSpPr>
        <p:spPr>
          <a:xfrm>
            <a:off x="2981160" y="92880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Lane 3</a:t>
            </a:r>
            <a:endParaRPr b="1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8" name="TextBox 8"/>
          <p:cNvSpPr/>
          <p:nvPr/>
        </p:nvSpPr>
        <p:spPr>
          <a:xfrm>
            <a:off x="3634560" y="92880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Lane 4</a:t>
            </a:r>
            <a:endParaRPr b="1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9" name="TextBox 9"/>
          <p:cNvSpPr/>
          <p:nvPr/>
        </p:nvSpPr>
        <p:spPr>
          <a:xfrm>
            <a:off x="5091480" y="2000160"/>
            <a:ext cx="385056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Lane 1 : molecular size markers (Lonza, Rockland, ME, USA) </a:t>
            </a:r>
            <a:endParaRPr b="1" lang="en-US" sz="10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Lane 2 : THP-1 cell only</a:t>
            </a:r>
            <a:endParaRPr b="1" lang="en-US" sz="10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Lane 3 : THP-1 + LPS for 6 hrs</a:t>
            </a:r>
            <a:endParaRPr b="1" lang="en-US" sz="10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Lane 4 : THP-1 + LPS for 24 hrs </a:t>
            </a:r>
            <a:endParaRPr b="1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0" name="TextBox 10"/>
          <p:cNvSpPr/>
          <p:nvPr/>
        </p:nvSpPr>
        <p:spPr>
          <a:xfrm>
            <a:off x="3502800" y="2422440"/>
            <a:ext cx="1211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WB : SHIP-1</a:t>
            </a:r>
            <a:endParaRPr b="1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1" name="TextBox 11"/>
          <p:cNvSpPr/>
          <p:nvPr/>
        </p:nvSpPr>
        <p:spPr>
          <a:xfrm>
            <a:off x="1001880" y="1289160"/>
            <a:ext cx="717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84kDa</a:t>
            </a:r>
            <a:endParaRPr b="1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2" name="TextBox 12"/>
          <p:cNvSpPr/>
          <p:nvPr/>
        </p:nvSpPr>
        <p:spPr>
          <a:xfrm>
            <a:off x="1001880" y="1636560"/>
            <a:ext cx="759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21 kDa</a:t>
            </a:r>
            <a:endParaRPr b="1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cxnSp>
        <p:nvCxnSpPr>
          <p:cNvPr id="53" name="직선 화살표 연결선 13"/>
          <p:cNvCxnSpPr/>
          <p:nvPr/>
        </p:nvCxnSpPr>
        <p:spPr>
          <a:xfrm flipH="1" flipV="1">
            <a:off x="4500000" y="1596240"/>
            <a:ext cx="540360" cy="252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54" name="TextBox 14"/>
          <p:cNvSpPr/>
          <p:nvPr/>
        </p:nvSpPr>
        <p:spPr>
          <a:xfrm>
            <a:off x="4986720" y="1468440"/>
            <a:ext cx="1149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HIP-1 (145kDa)</a:t>
            </a:r>
            <a:endParaRPr b="1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55" name="Picture 5" descr=""/>
          <p:cNvPicPr/>
          <p:nvPr/>
        </p:nvPicPr>
        <p:blipFill>
          <a:blip r:embed="rId2"/>
          <a:stretch/>
        </p:blipFill>
        <p:spPr>
          <a:xfrm>
            <a:off x="1817640" y="2994120"/>
            <a:ext cx="2857680" cy="1544400"/>
          </a:xfrm>
          <a:prstGeom prst="rect">
            <a:avLst/>
          </a:prstGeom>
          <a:ln w="0">
            <a:noFill/>
          </a:ln>
        </p:spPr>
      </p:pic>
      <p:sp>
        <p:nvSpPr>
          <p:cNvPr id="56" name="TextBox 16"/>
          <p:cNvSpPr/>
          <p:nvPr/>
        </p:nvSpPr>
        <p:spPr>
          <a:xfrm>
            <a:off x="3530520" y="4208400"/>
            <a:ext cx="1081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WB : Actin</a:t>
            </a:r>
            <a:endParaRPr b="1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cxnSp>
        <p:nvCxnSpPr>
          <p:cNvPr id="57" name="직선 화살표 연결선 17"/>
          <p:cNvCxnSpPr/>
          <p:nvPr/>
        </p:nvCxnSpPr>
        <p:spPr>
          <a:xfrm flipH="1" flipV="1">
            <a:off x="4531680" y="3432960"/>
            <a:ext cx="540360" cy="252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58" name="TextBox 18"/>
          <p:cNvSpPr/>
          <p:nvPr/>
        </p:nvSpPr>
        <p:spPr>
          <a:xfrm>
            <a:off x="5012280" y="3286080"/>
            <a:ext cx="2018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Actin (42kDa) : loading control</a:t>
            </a:r>
            <a:endParaRPr b="1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9" name="TextBox 19"/>
          <p:cNvSpPr/>
          <p:nvPr/>
        </p:nvSpPr>
        <p:spPr>
          <a:xfrm>
            <a:off x="1738080" y="299412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Lane 1</a:t>
            </a:r>
            <a:endParaRPr b="1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0" name="TextBox 20"/>
          <p:cNvSpPr/>
          <p:nvPr/>
        </p:nvSpPr>
        <p:spPr>
          <a:xfrm>
            <a:off x="2358720" y="299412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Lane 2</a:t>
            </a:r>
            <a:endParaRPr b="1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1" name="TextBox 21"/>
          <p:cNvSpPr/>
          <p:nvPr/>
        </p:nvSpPr>
        <p:spPr>
          <a:xfrm>
            <a:off x="2981160" y="299412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Lane 3</a:t>
            </a:r>
            <a:endParaRPr b="1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2" name="TextBox 22"/>
          <p:cNvSpPr/>
          <p:nvPr/>
        </p:nvSpPr>
        <p:spPr>
          <a:xfrm>
            <a:off x="3634560" y="299412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Lane 4</a:t>
            </a:r>
            <a:endParaRPr b="1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3" name="직선 연결선 23"/>
          <p:cNvSpPr/>
          <p:nvPr/>
        </p:nvSpPr>
        <p:spPr>
          <a:xfrm>
            <a:off x="1779480" y="3598920"/>
            <a:ext cx="428760" cy="1440"/>
          </a:xfrm>
          <a:prstGeom prst="line">
            <a:avLst/>
          </a:prstGeom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4" name="TextBox 24"/>
          <p:cNvSpPr/>
          <p:nvPr/>
        </p:nvSpPr>
        <p:spPr>
          <a:xfrm>
            <a:off x="1033200" y="344340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41 kDa</a:t>
            </a:r>
            <a:endParaRPr b="1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5" name="TextBox 25"/>
          <p:cNvSpPr/>
          <p:nvPr/>
        </p:nvSpPr>
        <p:spPr>
          <a:xfrm>
            <a:off x="4429080" y="4929120"/>
            <a:ext cx="4500720" cy="1735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buClr>
                <a:srgbClr val="00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 u="sng">
                <a:solidFill>
                  <a:srgbClr val="000000"/>
                </a:solidFill>
                <a:uFillTx/>
                <a:latin typeface="Arial"/>
                <a:ea typeface="Arial"/>
              </a:rPr>
              <a:t> </a:t>
            </a:r>
            <a:r>
              <a:rPr b="1" lang="en-US" sz="1200" spc="-1" strike="noStrike" u="sng">
                <a:solidFill>
                  <a:srgbClr val="0000ff"/>
                </a:solidFill>
                <a:uFillTx/>
                <a:latin typeface="Arial"/>
                <a:ea typeface="Arial"/>
              </a:rPr>
              <a:t>Each gel and blot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1" lang="en-US" sz="12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(1) </a:t>
            </a:r>
            <a:r>
              <a:rPr b="1" lang="en-US" sz="1200" spc="-1" strike="noStrike">
                <a:solidFill>
                  <a:srgbClr val="ff0000"/>
                </a:solidFill>
                <a:latin typeface="Arial"/>
                <a:ea typeface="Arial"/>
              </a:rPr>
              <a:t>SHIP-1 antibody test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(SHIP-1 band confirming done) </a:t>
            </a:r>
            <a:endParaRPr b="1" lang="en-US" sz="12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    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:  Based on the previous report (PMID: 20404275).</a:t>
            </a:r>
            <a:r>
              <a:rPr b="1" lang="ko-KR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1" lang="en-US" sz="12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HIP-1 confirming  test by LPS stimulation was done</a:t>
            </a:r>
            <a:endParaRPr b="1" lang="en-US" sz="12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ko-KR" sz="1200" spc="-1" strike="noStrike">
                <a:solidFill>
                  <a:srgbClr val="000000"/>
                </a:solidFill>
                <a:latin typeface="Arial"/>
                <a:ea typeface="Arial"/>
              </a:rPr>
              <a:t>       </a:t>
            </a:r>
            <a:endParaRPr b="1" lang="en-US" sz="12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(2) </a:t>
            </a:r>
            <a:r>
              <a:rPr b="1" lang="en-US" sz="1200" spc="-1" strike="noStrike">
                <a:solidFill>
                  <a:srgbClr val="ff0000"/>
                </a:solidFill>
                <a:latin typeface="Arial"/>
                <a:ea typeface="Arial"/>
              </a:rPr>
              <a:t>molecular size markers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</a:t>
            </a:r>
            <a:endParaRPr b="1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직사각형 1"/>
          <p:cNvSpPr/>
          <p:nvPr/>
        </p:nvSpPr>
        <p:spPr>
          <a:xfrm>
            <a:off x="157320" y="71280"/>
            <a:ext cx="3387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(2) Original blot data (Fig. 2D)</a:t>
            </a:r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67" name="Picture 2" descr=""/>
          <p:cNvPicPr/>
          <p:nvPr/>
        </p:nvPicPr>
        <p:blipFill>
          <a:blip r:embed="rId1"/>
          <a:stretch/>
        </p:blipFill>
        <p:spPr>
          <a:xfrm>
            <a:off x="2981160" y="709560"/>
            <a:ext cx="3214800" cy="91440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68" name="TextBox 6"/>
          <p:cNvSpPr/>
          <p:nvPr/>
        </p:nvSpPr>
        <p:spPr>
          <a:xfrm>
            <a:off x="3387600" y="43812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Lane 1</a:t>
            </a:r>
            <a:endParaRPr b="1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9" name="TextBox 7"/>
          <p:cNvSpPr/>
          <p:nvPr/>
        </p:nvSpPr>
        <p:spPr>
          <a:xfrm>
            <a:off x="4008240" y="43812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Lane 2</a:t>
            </a:r>
            <a:endParaRPr b="1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0" name="TextBox 8"/>
          <p:cNvSpPr/>
          <p:nvPr/>
        </p:nvSpPr>
        <p:spPr>
          <a:xfrm>
            <a:off x="4629960" y="43812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Lane 3</a:t>
            </a:r>
            <a:endParaRPr b="1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1" name="TextBox 9"/>
          <p:cNvSpPr/>
          <p:nvPr/>
        </p:nvSpPr>
        <p:spPr>
          <a:xfrm>
            <a:off x="5283000" y="43812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Lane 4</a:t>
            </a:r>
            <a:endParaRPr b="1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2" name="TextBox 10"/>
          <p:cNvSpPr/>
          <p:nvPr/>
        </p:nvSpPr>
        <p:spPr>
          <a:xfrm>
            <a:off x="6280200" y="1012680"/>
            <a:ext cx="1211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WB : SHIP-1</a:t>
            </a:r>
            <a:endParaRPr b="1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3" name="직선 연결선 13"/>
          <p:cNvSpPr/>
          <p:nvPr/>
        </p:nvSpPr>
        <p:spPr>
          <a:xfrm>
            <a:off x="2844720" y="942840"/>
            <a:ext cx="430200" cy="1800"/>
          </a:xfrm>
          <a:prstGeom prst="line">
            <a:avLst/>
          </a:prstGeom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4" name="직선 연결선 14"/>
          <p:cNvSpPr/>
          <p:nvPr/>
        </p:nvSpPr>
        <p:spPr>
          <a:xfrm>
            <a:off x="2851200" y="1306440"/>
            <a:ext cx="428400" cy="1800"/>
          </a:xfrm>
          <a:prstGeom prst="line">
            <a:avLst/>
          </a:prstGeom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5" name="TextBox 15"/>
          <p:cNvSpPr/>
          <p:nvPr/>
        </p:nvSpPr>
        <p:spPr>
          <a:xfrm>
            <a:off x="2105280" y="804960"/>
            <a:ext cx="717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84kDa</a:t>
            </a:r>
            <a:endParaRPr b="1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6" name="TextBox 16"/>
          <p:cNvSpPr/>
          <p:nvPr/>
        </p:nvSpPr>
        <p:spPr>
          <a:xfrm>
            <a:off x="2105280" y="1150920"/>
            <a:ext cx="759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21 kDa</a:t>
            </a:r>
            <a:endParaRPr b="1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77" name="Picture 3" descr=""/>
          <p:cNvPicPr/>
          <p:nvPr/>
        </p:nvPicPr>
        <p:blipFill>
          <a:blip r:embed="rId2"/>
          <a:stretch/>
        </p:blipFill>
        <p:spPr>
          <a:xfrm>
            <a:off x="2981160" y="1722600"/>
            <a:ext cx="3214800" cy="124128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78" name="직선 연결선 18"/>
          <p:cNvSpPr/>
          <p:nvPr/>
        </p:nvSpPr>
        <p:spPr>
          <a:xfrm>
            <a:off x="2851200" y="2635200"/>
            <a:ext cx="428400" cy="1800"/>
          </a:xfrm>
          <a:prstGeom prst="line">
            <a:avLst/>
          </a:prstGeom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9" name="TextBox 19"/>
          <p:cNvSpPr/>
          <p:nvPr/>
        </p:nvSpPr>
        <p:spPr>
          <a:xfrm>
            <a:off x="2105640" y="247968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52 kDa</a:t>
            </a:r>
            <a:endParaRPr b="1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80" name="Picture 4" descr=""/>
          <p:cNvPicPr/>
          <p:nvPr/>
        </p:nvPicPr>
        <p:blipFill>
          <a:blip r:embed="rId3"/>
          <a:srcRect l="1703" t="0" r="0" b="0"/>
          <a:stretch/>
        </p:blipFill>
        <p:spPr>
          <a:xfrm>
            <a:off x="3000240" y="3060720"/>
            <a:ext cx="3195720" cy="129708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81" name="직선 연결선 21"/>
          <p:cNvSpPr/>
          <p:nvPr/>
        </p:nvSpPr>
        <p:spPr>
          <a:xfrm>
            <a:off x="2851200" y="4002120"/>
            <a:ext cx="428400" cy="1440"/>
          </a:xfrm>
          <a:prstGeom prst="line">
            <a:avLst/>
          </a:prstGeom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2" name="TextBox 22"/>
          <p:cNvSpPr/>
          <p:nvPr/>
        </p:nvSpPr>
        <p:spPr>
          <a:xfrm>
            <a:off x="2105640" y="384660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52 kDa</a:t>
            </a:r>
            <a:endParaRPr b="1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3" name="TextBox 23"/>
          <p:cNvSpPr/>
          <p:nvPr/>
        </p:nvSpPr>
        <p:spPr>
          <a:xfrm>
            <a:off x="6283440" y="2189160"/>
            <a:ext cx="2495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WB : Phospho-Akt (Ser473)</a:t>
            </a:r>
            <a:endParaRPr b="1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4" name="TextBox 24"/>
          <p:cNvSpPr/>
          <p:nvPr/>
        </p:nvSpPr>
        <p:spPr>
          <a:xfrm>
            <a:off x="6275880" y="3556080"/>
            <a:ext cx="1349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WB : total Akt</a:t>
            </a:r>
            <a:endParaRPr b="1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85" name="Picture 5" descr=""/>
          <p:cNvPicPr/>
          <p:nvPr/>
        </p:nvPicPr>
        <p:blipFill>
          <a:blip r:embed="rId4"/>
          <a:srcRect l="570" t="0" r="0" b="0"/>
          <a:stretch/>
        </p:blipFill>
        <p:spPr>
          <a:xfrm>
            <a:off x="3000240" y="4454640"/>
            <a:ext cx="3195720" cy="132696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86" name="직선 연결선 26"/>
          <p:cNvSpPr/>
          <p:nvPr/>
        </p:nvSpPr>
        <p:spPr>
          <a:xfrm>
            <a:off x="2851200" y="4968720"/>
            <a:ext cx="428400" cy="1800"/>
          </a:xfrm>
          <a:prstGeom prst="line">
            <a:avLst/>
          </a:prstGeom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7" name="TextBox 27"/>
          <p:cNvSpPr/>
          <p:nvPr/>
        </p:nvSpPr>
        <p:spPr>
          <a:xfrm>
            <a:off x="2105640" y="481320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41 kDa</a:t>
            </a:r>
            <a:endParaRPr b="1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8" name="TextBox 28"/>
          <p:cNvSpPr/>
          <p:nvPr/>
        </p:nvSpPr>
        <p:spPr>
          <a:xfrm>
            <a:off x="6278760" y="4964040"/>
            <a:ext cx="913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WB : I</a:t>
            </a:r>
            <a:r>
              <a:rPr b="1" lang="el-GR" sz="1400" spc="-1" strike="noStrike">
                <a:solidFill>
                  <a:srgbClr val="000000"/>
                </a:solidFill>
                <a:latin typeface="Arial"/>
                <a:ea typeface="Arial"/>
              </a:rPr>
              <a:t>κ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1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89" name="Picture 6" descr=""/>
          <p:cNvPicPr/>
          <p:nvPr/>
        </p:nvPicPr>
        <p:blipFill>
          <a:blip r:embed="rId5"/>
          <a:srcRect l="4155" t="0" r="0" b="0"/>
          <a:stretch/>
        </p:blipFill>
        <p:spPr>
          <a:xfrm>
            <a:off x="3000240" y="5878440"/>
            <a:ext cx="3195720" cy="9082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90" name="직선 연결선 30"/>
          <p:cNvSpPr/>
          <p:nvPr/>
        </p:nvSpPr>
        <p:spPr>
          <a:xfrm>
            <a:off x="2851200" y="6423120"/>
            <a:ext cx="428400" cy="1440"/>
          </a:xfrm>
          <a:prstGeom prst="line">
            <a:avLst/>
          </a:prstGeom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1" name="TextBox 31"/>
          <p:cNvSpPr/>
          <p:nvPr/>
        </p:nvSpPr>
        <p:spPr>
          <a:xfrm>
            <a:off x="2105640" y="626760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41 kDa</a:t>
            </a:r>
            <a:endParaRPr b="1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2" name="TextBox 32"/>
          <p:cNvSpPr/>
          <p:nvPr/>
        </p:nvSpPr>
        <p:spPr>
          <a:xfrm>
            <a:off x="6275880" y="6178680"/>
            <a:ext cx="1081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WB : Actin</a:t>
            </a:r>
            <a:endParaRPr b="1" lang="en-US" sz="14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3" name="Picture 3" descr=""/>
          <p:cNvPicPr/>
          <p:nvPr/>
        </p:nvPicPr>
        <p:blipFill>
          <a:blip r:embed="rId1"/>
          <a:stretch/>
        </p:blipFill>
        <p:spPr>
          <a:xfrm>
            <a:off x="1550880" y="1282680"/>
            <a:ext cx="2930760" cy="1932120"/>
          </a:xfrm>
          <a:prstGeom prst="rect">
            <a:avLst/>
          </a:prstGeom>
          <a:ln w="0">
            <a:noFill/>
          </a:ln>
        </p:spPr>
      </p:pic>
      <p:sp>
        <p:nvSpPr>
          <p:cNvPr id="94" name="직선 연결선 3"/>
          <p:cNvSpPr/>
          <p:nvPr/>
        </p:nvSpPr>
        <p:spPr>
          <a:xfrm>
            <a:off x="1789200" y="1857240"/>
            <a:ext cx="428400" cy="1800"/>
          </a:xfrm>
          <a:prstGeom prst="line">
            <a:avLst/>
          </a:prstGeom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5" name="직선 연결선 4"/>
          <p:cNvSpPr/>
          <p:nvPr/>
        </p:nvSpPr>
        <p:spPr>
          <a:xfrm>
            <a:off x="1789200" y="2314440"/>
            <a:ext cx="428400" cy="1800"/>
          </a:xfrm>
          <a:prstGeom prst="line">
            <a:avLst/>
          </a:prstGeom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6" name="TextBox 5"/>
          <p:cNvSpPr/>
          <p:nvPr/>
        </p:nvSpPr>
        <p:spPr>
          <a:xfrm>
            <a:off x="1728720" y="142884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Lane 1</a:t>
            </a:r>
            <a:endParaRPr b="1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7" name="TextBox 6"/>
          <p:cNvSpPr/>
          <p:nvPr/>
        </p:nvSpPr>
        <p:spPr>
          <a:xfrm>
            <a:off x="2535120" y="142884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Lane 2</a:t>
            </a:r>
            <a:endParaRPr b="1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8" name="TextBox 7"/>
          <p:cNvSpPr/>
          <p:nvPr/>
        </p:nvSpPr>
        <p:spPr>
          <a:xfrm>
            <a:off x="3239280" y="142884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Lane 3</a:t>
            </a:r>
            <a:endParaRPr b="1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9" name="TextBox 8"/>
          <p:cNvSpPr/>
          <p:nvPr/>
        </p:nvSpPr>
        <p:spPr>
          <a:xfrm>
            <a:off x="1001880" y="1714680"/>
            <a:ext cx="759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84 kDa</a:t>
            </a:r>
            <a:endParaRPr b="1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0" name="TextBox 9"/>
          <p:cNvSpPr/>
          <p:nvPr/>
        </p:nvSpPr>
        <p:spPr>
          <a:xfrm>
            <a:off x="1001880" y="2163600"/>
            <a:ext cx="759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21 kDa</a:t>
            </a:r>
            <a:endParaRPr b="1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cxnSp>
        <p:nvCxnSpPr>
          <p:cNvPr id="101" name="직선 화살표 연결선 10"/>
          <p:cNvCxnSpPr/>
          <p:nvPr/>
        </p:nvCxnSpPr>
        <p:spPr>
          <a:xfrm flipH="1" flipV="1">
            <a:off x="3845880" y="2103120"/>
            <a:ext cx="929160" cy="216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102" name="TextBox 11"/>
          <p:cNvSpPr/>
          <p:nvPr/>
        </p:nvSpPr>
        <p:spPr>
          <a:xfrm>
            <a:off x="4755240" y="1949400"/>
            <a:ext cx="3379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HIP-1 (145kDa, bands were cropped)</a:t>
            </a:r>
            <a:endParaRPr b="1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3" name="TextBox 12"/>
          <p:cNvSpPr/>
          <p:nvPr/>
        </p:nvSpPr>
        <p:spPr>
          <a:xfrm>
            <a:off x="3077280" y="2714760"/>
            <a:ext cx="1211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WB : SHIP-1</a:t>
            </a:r>
            <a:endParaRPr b="1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4" name="TextBox 13"/>
          <p:cNvSpPr/>
          <p:nvPr/>
        </p:nvSpPr>
        <p:spPr>
          <a:xfrm>
            <a:off x="1706760" y="5357880"/>
            <a:ext cx="330048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Lane 1 : molecular size markers</a:t>
            </a:r>
            <a:endParaRPr b="1" lang="en-US" sz="14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Lane 2 : injection of PBS into mouse</a:t>
            </a:r>
            <a:endParaRPr b="1" lang="en-US" sz="14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Lane 3 : injection of MSU into mouse</a:t>
            </a:r>
            <a:endParaRPr b="1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105" name="Picture 4" descr=""/>
          <p:cNvPicPr/>
          <p:nvPr/>
        </p:nvPicPr>
        <p:blipFill>
          <a:blip r:embed="rId2"/>
          <a:stretch/>
        </p:blipFill>
        <p:spPr>
          <a:xfrm>
            <a:off x="1500120" y="3363840"/>
            <a:ext cx="2857680" cy="1636920"/>
          </a:xfrm>
          <a:prstGeom prst="rect">
            <a:avLst/>
          </a:prstGeom>
          <a:ln w="0">
            <a:noFill/>
          </a:ln>
        </p:spPr>
      </p:pic>
      <p:sp>
        <p:nvSpPr>
          <p:cNvPr id="106" name="직선 연결선 15"/>
          <p:cNvSpPr/>
          <p:nvPr/>
        </p:nvSpPr>
        <p:spPr>
          <a:xfrm>
            <a:off x="1789200" y="4562640"/>
            <a:ext cx="428400" cy="1440"/>
          </a:xfrm>
          <a:prstGeom prst="line">
            <a:avLst/>
          </a:prstGeom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7" name="TextBox 16"/>
          <p:cNvSpPr/>
          <p:nvPr/>
        </p:nvSpPr>
        <p:spPr>
          <a:xfrm>
            <a:off x="1728720" y="357192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Lane 1</a:t>
            </a:r>
            <a:endParaRPr b="1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8" name="TextBox 17"/>
          <p:cNvSpPr/>
          <p:nvPr/>
        </p:nvSpPr>
        <p:spPr>
          <a:xfrm>
            <a:off x="2535120" y="357192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Lane 2</a:t>
            </a:r>
            <a:endParaRPr b="1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9" name="TextBox 18"/>
          <p:cNvSpPr/>
          <p:nvPr/>
        </p:nvSpPr>
        <p:spPr>
          <a:xfrm>
            <a:off x="3239280" y="357192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Lane 3</a:t>
            </a:r>
            <a:endParaRPr b="1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0" name="TextBox 19"/>
          <p:cNvSpPr/>
          <p:nvPr/>
        </p:nvSpPr>
        <p:spPr>
          <a:xfrm>
            <a:off x="1126800" y="441000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42 kDa</a:t>
            </a:r>
            <a:endParaRPr b="1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1" name="TextBox 20"/>
          <p:cNvSpPr/>
          <p:nvPr/>
        </p:nvSpPr>
        <p:spPr>
          <a:xfrm>
            <a:off x="3430440" y="4643280"/>
            <a:ext cx="1081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WB : Actin</a:t>
            </a:r>
            <a:endParaRPr b="1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cxnSp>
        <p:nvCxnSpPr>
          <p:cNvPr id="112" name="직선 화살표 연결선 21"/>
          <p:cNvCxnSpPr/>
          <p:nvPr/>
        </p:nvCxnSpPr>
        <p:spPr>
          <a:xfrm flipH="1" flipV="1">
            <a:off x="3979440" y="4417200"/>
            <a:ext cx="929520" cy="252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113" name="TextBox 22"/>
          <p:cNvSpPr/>
          <p:nvPr/>
        </p:nvSpPr>
        <p:spPr>
          <a:xfrm>
            <a:off x="4885200" y="4264200"/>
            <a:ext cx="2765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ctin (42kDa) : loading control</a:t>
            </a:r>
            <a:endParaRPr b="1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4" name="직사각형 23"/>
          <p:cNvSpPr/>
          <p:nvPr/>
        </p:nvSpPr>
        <p:spPr>
          <a:xfrm>
            <a:off x="2481120" y="2019240"/>
            <a:ext cx="1357560" cy="1605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5" name="직사각형 24"/>
          <p:cNvSpPr/>
          <p:nvPr/>
        </p:nvSpPr>
        <p:spPr>
          <a:xfrm>
            <a:off x="161280" y="71280"/>
            <a:ext cx="4187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(2) Original mouse blot data (Fig. 4C)</a:t>
            </a:r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2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0-18T09:51:16Z</dcterms:created>
  <dc:creator>User</dc:creator>
  <dc:description/>
  <dc:language>en-US</dc:language>
  <cp:lastModifiedBy>김태종</cp:lastModifiedBy>
  <dcterms:modified xsi:type="dcterms:W3CDTF">2013-12-18T01:34:15Z</dcterms:modified>
  <cp:revision>45</cp:revision>
  <dc:subject/>
  <dc:title>슬라이드 1</dc:title>
</cp:coreProperties>
</file>